
<file path=[Content_Types].xml><?xml version="1.0" encoding="utf-8"?>
<Types xmlns="http://schemas.openxmlformats.org/package/2006/content-types">
  <Default Extension="docx" ContentType="application/vnd.openxmlformats-officedocument.wordprocessingml.document"/>
  <Default Extension="emf" ContentType="image/x-emf"/>
  <Default Extension="jpeg" ContentType="image/jpeg"/>
  <Default Extension="rels" ContentType="application/vnd.openxmlformats-package.relationships+xml"/>
  <Default Extension="tif" ContentType="image/tiff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  <p:sldId id="256" r:id="rId3"/>
    <p:sldId id="259" r:id="rId4"/>
    <p:sldId id="257" r:id="rId5"/>
  </p:sldIdLst>
  <p:sldSz cx="12192000" cy="6858000"/>
  <p:notesSz cx="6858000" cy="9144000"/>
  <p:defaultTextStyle>
    <a:defPPr>
      <a:defRPr lang="en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588"/>
    <p:restoredTop sz="95280"/>
  </p:normalViewPr>
  <p:slideViewPr>
    <p:cSldViewPr snapToGrid="0" snapToObjects="1">
      <p:cViewPr>
        <p:scale>
          <a:sx n="100" d="100"/>
          <a:sy n="100" d="100"/>
        </p:scale>
        <p:origin x="312" y="-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873AA8-B252-3B41-8738-44576409A9F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S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A9CFD23-50BF-704F-BAF3-CD14214FEB4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1EF52A0-C118-9A40-B171-3DED0B6DDB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ADFFE9-CB46-8145-9A70-1F04C61626DB}" type="datetimeFigureOut">
              <a:rPr lang="en-SE" smtClean="0"/>
              <a:t>2021-09-10</a:t>
            </a:fld>
            <a:endParaRPr lang="en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B486356-3F1E-194C-95EE-DA5710FACC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9B98B91-2E1B-FD48-91B6-DE467CE8A1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9AC6F2-4C7A-744F-BB06-138A94EB043E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23502997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A941B5-C54B-AB46-B4B0-4C8E5C4B545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S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7CC6CF1-8985-A248-860E-86262EB025E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59C0501-0F86-A044-ABAD-27119CFB0C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ADFFE9-CB46-8145-9A70-1F04C61626DB}" type="datetimeFigureOut">
              <a:rPr lang="en-SE" smtClean="0"/>
              <a:t>2021-09-10</a:t>
            </a:fld>
            <a:endParaRPr lang="en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325C821-3944-5342-BC18-5E338857F8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4EE2954-CAB5-FB49-A24D-FCC3D2F396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9AC6F2-4C7A-744F-BB06-138A94EB043E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15113453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1F0617A-7384-2243-A125-8C5CDC5B238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S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CBA0835-E9A0-4D41-BEC8-34D48927233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01CE666-39BD-4B40-941D-7946575C2B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ADFFE9-CB46-8145-9A70-1F04C61626DB}" type="datetimeFigureOut">
              <a:rPr lang="en-SE" smtClean="0"/>
              <a:t>2021-09-10</a:t>
            </a:fld>
            <a:endParaRPr lang="en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FA3093E-15D0-5A40-97E3-1E862BBE7A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E740061-4635-E147-B960-6ED20DC032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9AC6F2-4C7A-744F-BB06-138A94EB043E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40096739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2827B3-76EF-3B4F-B648-8211B7F9A2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S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30E2116-3A12-8240-964C-2665D923514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117C037-820F-A24C-B42E-BC1253832A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ADFFE9-CB46-8145-9A70-1F04C61626DB}" type="datetimeFigureOut">
              <a:rPr lang="en-SE" smtClean="0"/>
              <a:t>2021-09-10</a:t>
            </a:fld>
            <a:endParaRPr lang="en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1710D26-99D7-3F46-ADB4-D92A5F90F2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9BF4B3E-C8C3-A941-8C33-A162B6F9B1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9AC6F2-4C7A-744F-BB06-138A94EB043E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29824348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B95A277-3147-2646-8E76-2002B48D49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S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7D83A43-B938-6549-BF58-1C427E9C880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2BF279C-87A7-C644-8605-7C579212AC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ADFFE9-CB46-8145-9A70-1F04C61626DB}" type="datetimeFigureOut">
              <a:rPr lang="en-SE" smtClean="0"/>
              <a:t>2021-09-10</a:t>
            </a:fld>
            <a:endParaRPr lang="en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590867D-9C50-2741-B6A2-B6B61E6D43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5D2D87F-78B4-BB47-848F-79C5F4961C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9AC6F2-4C7A-744F-BB06-138A94EB043E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38515186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806382-D4DA-7B4F-A817-0564424A416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S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4BE8C1F-AFD2-E745-B81C-68035EB4764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SE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B9694FE-2B77-344D-9D80-5554C0B0F5E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SE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9EB7AC8-8534-1742-BC61-37A755371C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ADFFE9-CB46-8145-9A70-1F04C61626DB}" type="datetimeFigureOut">
              <a:rPr lang="en-SE" smtClean="0"/>
              <a:t>2021-09-10</a:t>
            </a:fld>
            <a:endParaRPr lang="en-S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1F78E7E-7FE2-5843-81D6-492455C50F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F1960FC-8769-DF4F-A1F7-E204A8B232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9AC6F2-4C7A-744F-BB06-138A94EB043E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5243804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6B4B7FC-7AEC-0E45-8792-F487A94858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S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6FF09F5-3914-6B4B-A9BE-A26C99556BC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E417915-0DB0-7649-A88B-CB654EE7C8E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S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353D012-A515-834D-8FFD-F77A251092D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09174EA-FE64-7F4C-B18D-614C5A5BA94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SE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6B43FB4-1BDF-9D48-9E1A-5B9FFDDD7B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ADFFE9-CB46-8145-9A70-1F04C61626DB}" type="datetimeFigureOut">
              <a:rPr lang="en-SE" smtClean="0"/>
              <a:t>2021-09-10</a:t>
            </a:fld>
            <a:endParaRPr lang="en-SE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BA2A916-D007-694D-B0A1-BDBDC6E9B6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5225719-2373-1C4F-9AEB-06D3A33FB0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9AC6F2-4C7A-744F-BB06-138A94EB043E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1417057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1DABB9-3CF1-E24D-9876-1D08E6E7BA1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S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CD7AAD6-7894-2C4C-8034-B24F6AADE1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ADFFE9-CB46-8145-9A70-1F04C61626DB}" type="datetimeFigureOut">
              <a:rPr lang="en-SE" smtClean="0"/>
              <a:t>2021-09-10</a:t>
            </a:fld>
            <a:endParaRPr lang="en-S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14C3EA9-70DB-B54E-BEAB-A50E593336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9AC3756-409A-F640-899D-F3F52C033A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9AC6F2-4C7A-744F-BB06-138A94EB043E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28213670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D580443-5847-314D-A478-B1A9424778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ADFFE9-CB46-8145-9A70-1F04C61626DB}" type="datetimeFigureOut">
              <a:rPr lang="en-SE" smtClean="0"/>
              <a:t>2021-09-10</a:t>
            </a:fld>
            <a:endParaRPr lang="en-S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8545BFF-F7BC-5449-B433-A8FDCC0F5D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96FE465-C5B2-854E-A541-F2BE21FE8E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9AC6F2-4C7A-744F-BB06-138A94EB043E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2418552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E2198F-7715-4F4D-BEBA-37B826738E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S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2A688D5-563E-1840-8159-55C87FD07DC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S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C4B18E0-68C4-1543-9536-BF664182113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56E83E8-DEC2-EC46-8A34-5F31B8BD14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ADFFE9-CB46-8145-9A70-1F04C61626DB}" type="datetimeFigureOut">
              <a:rPr lang="en-SE" smtClean="0"/>
              <a:t>2021-09-10</a:t>
            </a:fld>
            <a:endParaRPr lang="en-S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4DDF787-A8CB-9640-8F3C-2944759BCE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F4ED6CE-9F6D-404C-8014-4616250FE2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9AC6F2-4C7A-744F-BB06-138A94EB043E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11858889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9817D6-C3A3-0046-981A-A8A33DB442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SE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6A9215F-21E8-3647-8061-A53478B8AE2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S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717FE0E-E47B-8542-AFA5-AAB19AA0952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B3C3B28-83D4-CB40-B2E2-BBB909036A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ADFFE9-CB46-8145-9A70-1F04C61626DB}" type="datetimeFigureOut">
              <a:rPr lang="en-SE" smtClean="0"/>
              <a:t>2021-09-10</a:t>
            </a:fld>
            <a:endParaRPr lang="en-S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60AA575-827D-EA45-BC71-2F76E6F6DF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7D1C29A-096B-874C-A258-589B56CFC1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9AC6F2-4C7A-744F-BB06-138A94EB043E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13963324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1265E93-7E06-C345-9623-807993FAF56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S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9194AB9-A908-094A-9529-90B0E14EE70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79EDF5E-0A01-9449-AFEC-FEE7226CBEA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ADFFE9-CB46-8145-9A70-1F04C61626DB}" type="datetimeFigureOut">
              <a:rPr lang="en-SE" smtClean="0"/>
              <a:t>2021-09-10</a:t>
            </a:fld>
            <a:endParaRPr lang="en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74AC61E-00BD-FE4A-80A2-AA05AE4D794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23DF6C0-C118-A441-B612-AE9C5A0CC86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9AC6F2-4C7A-744F-BB06-138A94EB043E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29292366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Word_Document.docx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"/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"/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ti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"/><Relationship Id="rId2" Type="http://schemas.openxmlformats.org/officeDocument/2006/relationships/image" Target="../media/image7.ti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9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F517DF86-5116-8447-84F4-2535C3A35A2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43397310"/>
              </p:ext>
            </p:extLst>
          </p:nvPr>
        </p:nvGraphicFramePr>
        <p:xfrm>
          <a:off x="127000" y="0"/>
          <a:ext cx="5969000" cy="35941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81" name="Document" r:id="rId3" imgW="5969000" imgH="3594100" progId="Word.Document.12">
                  <p:embed/>
                </p:oleObj>
              </mc:Choice>
              <mc:Fallback>
                <p:oleObj name="Document" r:id="rId3" imgW="5969000" imgH="3594100" progId="Word.Document.12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61BFBFD8-FE8C-904F-A035-5ACA46BB002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27000" y="0"/>
                        <a:ext cx="5969000" cy="35941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Rectangle 4">
            <a:extLst>
              <a:ext uri="{FF2B5EF4-FFF2-40B4-BE49-F238E27FC236}">
                <a16:creationId xmlns:a16="http://schemas.microsoft.com/office/drawing/2014/main" id="{2C34539D-266E-614E-A51C-AAC871DC20B6}"/>
              </a:ext>
            </a:extLst>
          </p:cNvPr>
          <p:cNvSpPr/>
          <p:nvPr/>
        </p:nvSpPr>
        <p:spPr>
          <a:xfrm>
            <a:off x="-1" y="3594100"/>
            <a:ext cx="5968999" cy="7124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</a:pP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Supplemental figure S1.</a:t>
            </a:r>
            <a:r>
              <a:rPr lang="en-SE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Preclinical experiments.</a:t>
            </a:r>
            <a:endParaRPr lang="en-US" sz="1200" dirty="0">
              <a:solidFill>
                <a:srgbClr val="000000"/>
              </a:solidFill>
              <a:latin typeface="Times New Roman" panose="02020603050405020304" pitchFamily="18" charset="0"/>
              <a:ea typeface="Arial" panose="020B060402020202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Timeline of preclinical experimental design.</a:t>
            </a: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ABG: arterial blood gas, VBG: mixed venous blood gas. </a:t>
            </a:r>
            <a:endParaRPr lang="en-US" sz="1200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Arial" panose="020B060402020202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5432234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155A1853-779B-C74F-AC14-395885A1356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4229100" cy="339090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C97D65D7-B246-0542-AA84-AD54E2EF6D0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229100" y="0"/>
            <a:ext cx="4229100" cy="3390900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AFAAD99B-A04C-144B-8D8E-9E782D98A164}"/>
              </a:ext>
            </a:extLst>
          </p:cNvPr>
          <p:cNvSpPr txBox="1"/>
          <p:nvPr/>
        </p:nvSpPr>
        <p:spPr>
          <a:xfrm>
            <a:off x="0" y="3285659"/>
            <a:ext cx="12192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S2a-b. P</a:t>
            </a:r>
            <a:r>
              <a:rPr lang="en-SE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reclinical experiments.</a:t>
            </a:r>
            <a:endParaRPr lang="sv-SE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sv-S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aracteristics</a:t>
            </a:r>
            <a:r>
              <a:rPr lang="sv-S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sv-S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sv-S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e </a:t>
            </a:r>
            <a:r>
              <a:rPr lang="sv-S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acteremia</a:t>
            </a:r>
            <a:r>
              <a:rPr lang="sv-S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sepsis </a:t>
            </a:r>
            <a:r>
              <a:rPr lang="sv-S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odel</a:t>
            </a:r>
            <a:r>
              <a:rPr lang="sv-S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(a) </a:t>
            </a:r>
            <a:r>
              <a:rPr lang="sv-S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acterial</a:t>
            </a:r>
            <a:r>
              <a:rPr lang="sv-S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fusion in CFU/</a:t>
            </a:r>
            <a:r>
              <a:rPr lang="sv-S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our</a:t>
            </a:r>
            <a:r>
              <a:rPr lang="sv-S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(b) </a:t>
            </a:r>
            <a:r>
              <a:rPr lang="sv-S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lood</a:t>
            </a:r>
            <a:r>
              <a:rPr lang="sv-S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sv-S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ultures</a:t>
            </a:r>
            <a:r>
              <a:rPr lang="sv-S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sv-S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howing</a:t>
            </a:r>
            <a:r>
              <a:rPr lang="sv-S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FU per ml </a:t>
            </a:r>
            <a:r>
              <a:rPr lang="sv-S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lood</a:t>
            </a:r>
            <a:r>
              <a:rPr lang="sv-S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sv-S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uring</a:t>
            </a:r>
            <a:r>
              <a:rPr lang="sv-S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sv-S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acterial</a:t>
            </a:r>
            <a:r>
              <a:rPr lang="sv-S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fusion. </a:t>
            </a:r>
          </a:p>
          <a:p>
            <a:r>
              <a:rPr lang="sv-S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 (</a:t>
            </a:r>
            <a:r>
              <a:rPr lang="sv-S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hite</a:t>
            </a:r>
            <a:r>
              <a:rPr lang="sv-S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no </a:t>
            </a:r>
            <a:r>
              <a:rPr lang="sv-S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acteria</a:t>
            </a:r>
            <a:r>
              <a:rPr lang="sv-S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sv-S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fused</a:t>
            </a:r>
            <a:r>
              <a:rPr lang="sv-S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no </a:t>
            </a:r>
            <a:r>
              <a:rPr lang="sv-S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acteria</a:t>
            </a:r>
            <a:r>
              <a:rPr lang="sv-S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sv-S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und</a:t>
            </a:r>
            <a:r>
              <a:rPr lang="sv-S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sv-S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lood</a:t>
            </a:r>
            <a:r>
              <a:rPr lang="sv-S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sv-S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ultures</a:t>
            </a:r>
            <a:r>
              <a:rPr lang="sv-S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Sepsis-1 (</a:t>
            </a:r>
            <a:r>
              <a:rPr lang="sv-S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ight</a:t>
            </a:r>
            <a:r>
              <a:rPr lang="sv-S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ray) and Sepsis-2 (dark gray). </a:t>
            </a:r>
          </a:p>
          <a:p>
            <a:endParaRPr lang="sv-SE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F8E65B45-361F-F549-ACCB-3CBAA4013D99}"/>
              </a:ext>
            </a:extLst>
          </p:cNvPr>
          <p:cNvSpPr txBox="1"/>
          <p:nvPr/>
        </p:nvSpPr>
        <p:spPr>
          <a:xfrm>
            <a:off x="3933826" y="0"/>
            <a:ext cx="295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E" dirty="0"/>
              <a:t>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B9E6626-4AF9-A54E-8900-0499E8EA13A5}"/>
              </a:ext>
            </a:extLst>
          </p:cNvPr>
          <p:cNvSpPr txBox="1"/>
          <p:nvPr/>
        </p:nvSpPr>
        <p:spPr>
          <a:xfrm>
            <a:off x="8162926" y="0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E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418082755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Rectangle 13">
            <a:extLst>
              <a:ext uri="{FF2B5EF4-FFF2-40B4-BE49-F238E27FC236}">
                <a16:creationId xmlns:a16="http://schemas.microsoft.com/office/drawing/2014/main" id="{0E66A78D-A152-9F4E-BC2C-3D1063564960}"/>
              </a:ext>
            </a:extLst>
          </p:cNvPr>
          <p:cNvSpPr/>
          <p:nvPr/>
        </p:nvSpPr>
        <p:spPr>
          <a:xfrm>
            <a:off x="0" y="3467100"/>
            <a:ext cx="12192000" cy="113710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</a:pPr>
            <a:r>
              <a:rPr lang="sv-S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S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a-c. P</a:t>
            </a:r>
            <a:r>
              <a:rPr lang="en-SE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reclinical experiments.</a:t>
            </a:r>
            <a:endParaRPr lang="en-US" sz="1200" dirty="0">
              <a:solidFill>
                <a:srgbClr val="000000"/>
              </a:solidFill>
              <a:latin typeface="Times New Roman" panose="02020603050405020304" pitchFamily="18" charset="0"/>
              <a:ea typeface="Arial" panose="020B060402020202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15000"/>
              </a:lnSpc>
            </a:pP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(a) Negative within-subject correlation between plasma hyaluronan concentration and effective plasma HYAL activity 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(r= -.38, p=.026)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and (b) effective plasma HYAL activity and HYAL inhibition (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r= -.824, p&lt;.001)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but not for (c) plasma hyaluronan concentration and HYAL inhibition (p=.506). Each line represents a linear regression between three values (T=0, 6 and 12) of individual experiments from which a pooled within-subject correlation is calculated according to the </a:t>
            </a:r>
            <a:r>
              <a:rPr lang="en-SE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Bland Altman method. The experimental groups  (control, Sepsis-1 and Sepsis-2) are shown separetely to facilitate the visualization of each individual regression line.</a:t>
            </a:r>
            <a:endParaRPr lang="en-US" sz="1200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Arial" panose="020B0604020202020204" pitchFamily="34" charset="0"/>
              <a:cs typeface="Times New Roman" panose="02020603050405020304" pitchFamily="18" charset="0"/>
            </a:endParaRP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31B37377-4FC9-B04A-B9DE-37234AF027F8}"/>
              </a:ext>
            </a:extLst>
          </p:cNvPr>
          <p:cNvGrpSpPr/>
          <p:nvPr/>
        </p:nvGrpSpPr>
        <p:grpSpPr>
          <a:xfrm>
            <a:off x="0" y="-25758"/>
            <a:ext cx="12192000" cy="3416658"/>
            <a:chOff x="0" y="-25758"/>
            <a:chExt cx="12192000" cy="3416658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90E1727C-30DA-1B4C-99D9-8558840D6529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0" y="0"/>
              <a:ext cx="4229100" cy="3390900"/>
            </a:xfrm>
            <a:prstGeom prst="rect">
              <a:avLst/>
            </a:prstGeom>
          </p:spPr>
        </p:pic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BC5ADBAF-273D-A94C-8289-ED67A3DFEC5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981450" y="0"/>
              <a:ext cx="4229100" cy="3390900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6792B266-5840-FA4B-8E32-AC0D9F6EC380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7962900" y="0"/>
              <a:ext cx="4229100" cy="3390900"/>
            </a:xfrm>
            <a:prstGeom prst="rect">
              <a:avLst/>
            </a:prstGeom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D8942AAE-57E6-154E-AC42-F665BC3A8806}"/>
                </a:ext>
              </a:extLst>
            </p:cNvPr>
            <p:cNvSpPr txBox="1"/>
            <p:nvPr/>
          </p:nvSpPr>
          <p:spPr>
            <a:xfrm>
              <a:off x="3481991" y="-25758"/>
              <a:ext cx="29527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SE" dirty="0"/>
                <a:t>a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9BD20D08-3E79-F44A-9B9C-A0AB075FEF8A}"/>
                </a:ext>
              </a:extLst>
            </p:cNvPr>
            <p:cNvSpPr txBox="1"/>
            <p:nvPr/>
          </p:nvSpPr>
          <p:spPr>
            <a:xfrm>
              <a:off x="7462973" y="-25758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SE" dirty="0"/>
                <a:t>b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B33EABD4-9473-1449-8EC0-406B9C27673D}"/>
                </a:ext>
              </a:extLst>
            </p:cNvPr>
            <p:cNvSpPr txBox="1"/>
            <p:nvPr/>
          </p:nvSpPr>
          <p:spPr>
            <a:xfrm>
              <a:off x="11479168" y="-25758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SE" dirty="0"/>
                <a:t>c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34ADD6AB-1338-1D4E-9DA1-C79F630FCFA7}"/>
                </a:ext>
              </a:extLst>
            </p:cNvPr>
            <p:cNvSpPr txBox="1"/>
            <p:nvPr/>
          </p:nvSpPr>
          <p:spPr>
            <a:xfrm rot="16200000">
              <a:off x="-1214275" y="1373183"/>
              <a:ext cx="2690160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SE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lasma hyaluronan concentration (ng/ml)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9D1200AA-1DE4-3D41-A4FC-32B006F67D38}"/>
                </a:ext>
              </a:extLst>
            </p:cNvPr>
            <p:cNvSpPr txBox="1"/>
            <p:nvPr/>
          </p:nvSpPr>
          <p:spPr>
            <a:xfrm rot="16200000">
              <a:off x="2845232" y="1346617"/>
              <a:ext cx="2536272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SE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ffective plasma HYAL activity (U/ml)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1F887F2A-5B81-5A41-91EC-7845038D4FDA}"/>
                </a:ext>
              </a:extLst>
            </p:cNvPr>
            <p:cNvSpPr txBox="1"/>
            <p:nvPr/>
          </p:nvSpPr>
          <p:spPr>
            <a:xfrm>
              <a:off x="1093356" y="3087195"/>
              <a:ext cx="2536272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SE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ffective plasma HYAL activity (U/ml)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CCC5993F-B68D-F94B-8386-162AA9E0657E}"/>
                </a:ext>
              </a:extLst>
            </p:cNvPr>
            <p:cNvSpPr txBox="1"/>
            <p:nvPr/>
          </p:nvSpPr>
          <p:spPr>
            <a:xfrm rot="16200000">
              <a:off x="6748625" y="1373183"/>
              <a:ext cx="2690160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SE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lasma hyaluronan concentration (ng/ml)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CF67859F-DF01-B34E-98A6-BB06DC08F053}"/>
                </a:ext>
              </a:extLst>
            </p:cNvPr>
            <p:cNvSpPr txBox="1"/>
            <p:nvPr/>
          </p:nvSpPr>
          <p:spPr>
            <a:xfrm>
              <a:off x="5124988" y="3088619"/>
              <a:ext cx="1955985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SE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lasma HYAL inhibition (%)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3351AF01-A70B-1A45-A502-2D1F58246225}"/>
                </a:ext>
              </a:extLst>
            </p:cNvPr>
            <p:cNvSpPr txBox="1"/>
            <p:nvPr/>
          </p:nvSpPr>
          <p:spPr>
            <a:xfrm>
              <a:off x="9223282" y="3087195"/>
              <a:ext cx="1955985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SE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lasma HYAL inhibition (%)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98708874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>
            <a:extLst>
              <a:ext uri="{FF2B5EF4-FFF2-40B4-BE49-F238E27FC236}">
                <a16:creationId xmlns:a16="http://schemas.microsoft.com/office/drawing/2014/main" id="{81579B85-97EA-6A40-842E-D3344E18CE20}"/>
              </a:ext>
            </a:extLst>
          </p:cNvPr>
          <p:cNvSpPr txBox="1"/>
          <p:nvPr/>
        </p:nvSpPr>
        <p:spPr>
          <a:xfrm>
            <a:off x="11430" y="3613738"/>
            <a:ext cx="1218057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S4a-c.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SE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reclinical experiments.</a:t>
            </a:r>
            <a:endParaRPr lang="sv-SE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sv-S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ooled</a:t>
            </a:r>
            <a:r>
              <a:rPr lang="sv-S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ata </a:t>
            </a:r>
            <a:r>
              <a:rPr lang="sv-S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sv-S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sv-S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eptic</a:t>
            </a:r>
            <a:r>
              <a:rPr lang="sv-S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sv-S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hock</a:t>
            </a:r>
            <a:r>
              <a:rPr lang="sv-S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atients and </a:t>
            </a:r>
            <a:r>
              <a:rPr lang="sv-S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ealthy</a:t>
            </a:r>
            <a:r>
              <a:rPr lang="sv-S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sv-S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olunteers</a:t>
            </a:r>
            <a:r>
              <a:rPr lang="sv-S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sv-S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howing</a:t>
            </a:r>
            <a:r>
              <a:rPr lang="sv-S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rrelation </a:t>
            </a:r>
            <a:r>
              <a:rPr lang="sv-S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tween</a:t>
            </a:r>
            <a:r>
              <a:rPr lang="sv-S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b) </a:t>
            </a:r>
            <a:r>
              <a:rPr lang="sv-S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ffective</a:t>
            </a:r>
            <a:r>
              <a:rPr lang="sv-S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lasma hyaluronidase activity and hyaluronidase inhibition. No correlation </a:t>
            </a:r>
            <a:r>
              <a:rPr lang="sv-S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und</a:t>
            </a:r>
            <a:r>
              <a:rPr lang="sv-S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sv-S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tween</a:t>
            </a:r>
            <a:r>
              <a:rPr lang="sv-S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a) plasma hyaluronan concentration and  </a:t>
            </a:r>
            <a:r>
              <a:rPr lang="sv-S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ffective</a:t>
            </a:r>
            <a:r>
              <a:rPr lang="sv-S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sv-S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yaluronidase</a:t>
            </a:r>
            <a:r>
              <a:rPr lang="sv-S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ctivity and  (c) plasma hyaluronan concentration and  hyaluronidase inhibition. </a:t>
            </a:r>
          </a:p>
          <a:p>
            <a:r>
              <a:rPr lang="sv-S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relation and p-</a:t>
            </a:r>
            <a:r>
              <a:rPr lang="sv-S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alue</a:t>
            </a:r>
            <a:r>
              <a:rPr lang="sv-S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rom </a:t>
            </a:r>
            <a:r>
              <a:rPr lang="en-SE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Spearman’s rank-order test.</a:t>
            </a:r>
            <a:endParaRPr lang="sv-SE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315679AD-6890-174A-94B8-F5C8217E5DC0}"/>
              </a:ext>
            </a:extLst>
          </p:cNvPr>
          <p:cNvGrpSpPr/>
          <p:nvPr/>
        </p:nvGrpSpPr>
        <p:grpSpPr>
          <a:xfrm>
            <a:off x="0" y="0"/>
            <a:ext cx="12057338" cy="3429000"/>
            <a:chOff x="0" y="0"/>
            <a:chExt cx="12057338" cy="3429000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1100F412-C135-9A4A-8064-BA1B083DF929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0" y="38100"/>
              <a:ext cx="4229100" cy="3390900"/>
            </a:xfrm>
            <a:prstGeom prst="rect">
              <a:avLst/>
            </a:prstGeom>
          </p:spPr>
        </p:pic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EBC21200-8A10-EB41-B3CD-84EF4167F4E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914119" y="0"/>
              <a:ext cx="4229100" cy="3390900"/>
            </a:xfrm>
            <a:prstGeom prst="rect">
              <a:avLst/>
            </a:prstGeom>
          </p:spPr>
        </p:pic>
        <p:sp>
          <p:nvSpPr>
            <p:cNvPr id="2" name="Rectangle 1">
              <a:extLst>
                <a:ext uri="{FF2B5EF4-FFF2-40B4-BE49-F238E27FC236}">
                  <a16:creationId xmlns:a16="http://schemas.microsoft.com/office/drawing/2014/main" id="{CC3BA6D5-F1AF-FC4D-AE8E-5638A096C0D8}"/>
                </a:ext>
              </a:extLst>
            </p:cNvPr>
            <p:cNvSpPr/>
            <p:nvPr/>
          </p:nvSpPr>
          <p:spPr>
            <a:xfrm>
              <a:off x="4997618" y="184738"/>
              <a:ext cx="1143262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1100" dirty="0">
                  <a:solidFill>
                    <a:srgbClr val="000000"/>
                  </a:solidFill>
                  <a:latin typeface="Times New Roman" panose="02020603050405020304" pitchFamily="18" charset="0"/>
                  <a:ea typeface="Arial" panose="020B0604020202020204" pitchFamily="34" charset="0"/>
                  <a:cs typeface="Times New Roman" panose="02020603050405020304" pitchFamily="18" charset="0"/>
                </a:rPr>
                <a:t>r=-0.697, p&lt;0.01</a:t>
              </a:r>
              <a:endParaRPr lang="en-SE" sz="1100" dirty="0"/>
            </a:p>
          </p:txBody>
        </p:sp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CC30F624-9DFE-8645-B7CB-16A9723DC532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7828238" y="38100"/>
              <a:ext cx="4229100" cy="3390900"/>
            </a:xfrm>
            <a:prstGeom prst="rect">
              <a:avLst/>
            </a:prstGeom>
          </p:spPr>
        </p:pic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53E646F9-C9BC-714B-A6A3-4D32818CAF12}"/>
                </a:ext>
              </a:extLst>
            </p:cNvPr>
            <p:cNvSpPr txBox="1"/>
            <p:nvPr/>
          </p:nvSpPr>
          <p:spPr>
            <a:xfrm>
              <a:off x="3618845" y="38100"/>
              <a:ext cx="29527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SE" dirty="0"/>
                <a:t>a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1559BA4B-0BA5-C74C-8D64-3FAEDF0B17AC}"/>
                </a:ext>
              </a:extLst>
            </p:cNvPr>
            <p:cNvSpPr txBox="1"/>
            <p:nvPr/>
          </p:nvSpPr>
          <p:spPr>
            <a:xfrm>
              <a:off x="7237690" y="38100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SE" dirty="0"/>
                <a:t>b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B022A624-2A94-C047-A519-8E481B1C2AA1}"/>
                </a:ext>
              </a:extLst>
            </p:cNvPr>
            <p:cNvSpPr txBox="1"/>
            <p:nvPr/>
          </p:nvSpPr>
          <p:spPr>
            <a:xfrm>
              <a:off x="11766938" y="38100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SE" dirty="0"/>
                <a:t>c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0E3A3106-8277-5D43-87B5-717ADA400921}"/>
                </a:ext>
              </a:extLst>
            </p:cNvPr>
            <p:cNvSpPr txBox="1"/>
            <p:nvPr/>
          </p:nvSpPr>
          <p:spPr>
            <a:xfrm rot="16200000">
              <a:off x="2810409" y="1300748"/>
              <a:ext cx="2536272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SE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ffective plasma HYAL activity (U/ml)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D8D1DDF9-1596-7541-AF71-3B98FAB34C9D}"/>
                </a:ext>
              </a:extLst>
            </p:cNvPr>
            <p:cNvSpPr txBox="1"/>
            <p:nvPr/>
          </p:nvSpPr>
          <p:spPr>
            <a:xfrm>
              <a:off x="1082573" y="3129290"/>
              <a:ext cx="2536272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SE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ffective plasma HYAL activity (U/ml)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DA0BE8DF-9A39-6B45-A8D4-9E8F300432F0}"/>
                </a:ext>
              </a:extLst>
            </p:cNvPr>
            <p:cNvSpPr txBox="1"/>
            <p:nvPr/>
          </p:nvSpPr>
          <p:spPr>
            <a:xfrm rot="16200000">
              <a:off x="-1202101" y="1300748"/>
              <a:ext cx="2690160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SE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lasma hyaluronan concentration (ng/ml)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8F50E3BC-D841-374F-A88E-A638A9E35C64}"/>
                </a:ext>
              </a:extLst>
            </p:cNvPr>
            <p:cNvSpPr txBox="1"/>
            <p:nvPr/>
          </p:nvSpPr>
          <p:spPr>
            <a:xfrm rot="16200000">
              <a:off x="6592307" y="1300748"/>
              <a:ext cx="2690160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SE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lasma hyaluronan concentration (ng/ml)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DE714E29-2A75-924E-A580-F5233B44780B}"/>
                </a:ext>
              </a:extLst>
            </p:cNvPr>
            <p:cNvSpPr txBox="1"/>
            <p:nvPr/>
          </p:nvSpPr>
          <p:spPr>
            <a:xfrm>
              <a:off x="4997618" y="3129290"/>
              <a:ext cx="1955985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SE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lasma HYAL inhibition (%)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D707B525-FDF5-A34B-A027-5676900CDDB2}"/>
                </a:ext>
              </a:extLst>
            </p:cNvPr>
            <p:cNvSpPr txBox="1"/>
            <p:nvPr/>
          </p:nvSpPr>
          <p:spPr>
            <a:xfrm>
              <a:off x="9318606" y="3129290"/>
              <a:ext cx="1955985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SE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lasma HYAL inhibition (%)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7146010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813</TotalTime>
  <Words>384</Words>
  <Application>Microsoft Macintosh PowerPoint</Application>
  <PresentationFormat>Widescreen</PresentationFormat>
  <Paragraphs>32</Paragraphs>
  <Slides>4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Office Theme</vt:lpstr>
      <vt:lpstr>Document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Jaap van der Heijden</cp:lastModifiedBy>
  <cp:revision>57</cp:revision>
  <dcterms:created xsi:type="dcterms:W3CDTF">2020-06-17T19:44:37Z</dcterms:created>
  <dcterms:modified xsi:type="dcterms:W3CDTF">2021-09-10T09:05:39Z</dcterms:modified>
</cp:coreProperties>
</file>